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7724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1C279C-4E7B-41ED-A95D-D1B666BB3E3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88800" y="274320"/>
            <a:ext cx="6994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88800" y="1600200"/>
            <a:ext cx="6994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88800" y="3964320"/>
            <a:ext cx="6994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67563E-3A73-4573-98DC-D10C463CC0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88800" y="274320"/>
            <a:ext cx="6994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88800" y="1600200"/>
            <a:ext cx="34131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972960" y="1600200"/>
            <a:ext cx="34131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88800" y="3964320"/>
            <a:ext cx="34131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972960" y="3964320"/>
            <a:ext cx="34131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B121EF-EA0A-4F8A-B8FC-D2FF84100F1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88800" y="274320"/>
            <a:ext cx="6994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88800" y="1600200"/>
            <a:ext cx="22521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754000" y="1600200"/>
            <a:ext cx="22521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119200" y="1600200"/>
            <a:ext cx="22521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88800" y="3964320"/>
            <a:ext cx="22521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754000" y="3964320"/>
            <a:ext cx="22521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119200" y="3964320"/>
            <a:ext cx="22521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FE68EA-EB07-4134-B415-1CF0129448D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88800" y="274320"/>
            <a:ext cx="6994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88800" y="1600200"/>
            <a:ext cx="69948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1D3506-7B5A-4C60-B4B1-8E198FDC7B9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88800" y="274320"/>
            <a:ext cx="6994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88800" y="1600200"/>
            <a:ext cx="6994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FC7BFB-1A6F-4AAD-A8E9-24E15E281F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88800" y="274320"/>
            <a:ext cx="6994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88800" y="1600200"/>
            <a:ext cx="34131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972960" y="1600200"/>
            <a:ext cx="34131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F4FFF2-39BC-443A-ABE1-1429700A3A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88800" y="274320"/>
            <a:ext cx="6994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A5F50E-8712-441C-917F-0606FE0D5CE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88800" y="274320"/>
            <a:ext cx="69948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0BA604-EBEE-4A95-88FF-5B4BBAA45F7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88800" y="274320"/>
            <a:ext cx="6994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88800" y="1600200"/>
            <a:ext cx="34131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972960" y="1600200"/>
            <a:ext cx="34131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88800" y="3964320"/>
            <a:ext cx="34131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1E57F1-E3B6-471F-8882-7EEB35518F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88800" y="274320"/>
            <a:ext cx="6994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88800" y="1600200"/>
            <a:ext cx="341316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972960" y="1600200"/>
            <a:ext cx="34131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972960" y="3964320"/>
            <a:ext cx="34131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89D86C-1BCC-4491-85E9-0CBD9270A8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88800" y="274320"/>
            <a:ext cx="6994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88800" y="1600200"/>
            <a:ext cx="34131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972960" y="1600200"/>
            <a:ext cx="341316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88800" y="3964320"/>
            <a:ext cx="6994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A90D10-5C0B-46A2-A938-50DA918408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88800" y="274320"/>
            <a:ext cx="69948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88800" y="1600200"/>
            <a:ext cx="6994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88800" y="6356520"/>
            <a:ext cx="18129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655720" y="6356520"/>
            <a:ext cx="24609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570640" y="6356520"/>
            <a:ext cx="18129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B91779C-0165-4943-A332-BE069F2A883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55520" y="503280"/>
          <a:ext cx="7467480" cy="5662440"/>
        </p:xfrm>
        <a:graphic>
          <a:graphicData uri="http://schemas.openxmlformats.org/drawingml/2006/table">
            <a:tbl>
              <a:tblPr/>
              <a:tblGrid>
                <a:gridCol w="1523880"/>
                <a:gridCol w="5029200"/>
                <a:gridCol w="914400"/>
              </a:tblGrid>
              <a:tr h="298440"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Name of Gen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rimer Sequenc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roduct Siz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4800"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RF_Amplifica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P :  5’ CATGCCATGGATGTCGTGGCAAACCTACG 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RP:   5’ CGGGATCCCTACAGGCCCTGTTCTGCAAG 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402b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5160"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RF_Sense stran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P :5’CCGCTCGAG ATGTCGTGGCAAACCTACG 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RP: 5’ CGGAATTCCTACAGGCCCTGTTCTGCAAG 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402b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4800"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RF_Anti Sense stran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P :5’ GCTCTAGA ATGTCGTGGCAAACCTACG 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RP: 5’ CGGGATCCCTACAGGCCCTGTTCTGCAAG 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402b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6600"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RF_Express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C_Prof Con_F1 :  5’ CCTTGGTGGCGCAAAGTTTATGGT  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C_Prof Con_R1:  5’  TCTCCACAACCATGTTGCATTGCC  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64b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5160"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P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C_NtAP1_F:  5’ AAGAGGAGGGGAGGTTTAGCG  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C_NtAP1_R: 5’ CAAGCGTCTCTCTGCGTATG  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77 b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4800"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SOC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C_NtSOC1_F: 5’ TGAAAACCAAGTTGGGGAAC  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C_NtSOC1_R: 5’ ACTGACACTCCGCTCCAACT  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75 b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4800"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T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C_NtFT4_F:  5’ CAATGCATGTGGCTTGAAAC  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C_NtFT4_R: 5’ TGCTGGGATATCTGTGACCA  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72 b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5160"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LC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C_AtFLC_1_F: 5’ GTCGCTCTTCTCGTCGTCTC  3’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C_AtFLC_1_R: 5’ CCACAAGCTTGCTATCCACA  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90 b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6600"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FT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C_NtFT1_F: 5’ GGTTATGGTGGACCCTGATG  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C_NtFT1_R: 5’ GCCATCCTGGAGCATACACT  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215 b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4800"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CLV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C_Nt CLV1_F ::  5’-CGATCATGGTTTCTCGGCTG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C_Nt CLV1_R ::  5’- GCCCCTTTTGCACCATGTAA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62 b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5160"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WU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C_Nt WUS_F :: 5’-CTGTCCATCCGCTTCTTCTC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C_Nt WUS_R :: 5’-GGATCAACTCCAACCCATGT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68 b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4800"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RP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C_ARP6_F: 5’-TCCCAGAGATGATGTTTCGTC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C_ARP6_R: 5’- TGAAGATGAGAATGGCAGGA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00 b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5160"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RP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C_Sola_ARP4_F1:5’-TCATTCAAGCGGAAGGAGAT-3’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C_Sola_ARP4_R1:5’- ATATGGAGTATCTGGGGCTCG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50b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6240"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PIP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C_Nt_PIP2_1F: 5’- TGACCCTGAGGAGCTAGGAA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C_Nt_PIP2_1R: 5’- CCAACACCACCACATTGTTC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56b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5160"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BP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BP1:5’ TCTGGTGAGGAACATTGCTG -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ABP1:5’ CACTGCCCTTGAGAACAACA -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194b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34800"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L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C_L25_F:  5’  CCCCTCACCACAGAGTCTGC 3’ 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BC_L25_R: 5’ AAGGGTGTTGTTGTCCTCAATCTT 3’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8800" rIns="28800" tIns="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N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Calibri"/>
                        </a:rPr>
                        <a:t>51bp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28800" marR="288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Box 9"/>
          <p:cNvSpPr/>
          <p:nvPr/>
        </p:nvSpPr>
        <p:spPr>
          <a:xfrm>
            <a:off x="0" y="0"/>
            <a:ext cx="228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dditional File 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2-25T07:03:37Z</dcterms:created>
  <dc:creator>gbu</dc:creator>
  <dc:description/>
  <dc:language>en-US</dc:language>
  <cp:lastModifiedBy>Bhupendra</cp:lastModifiedBy>
  <dcterms:modified xsi:type="dcterms:W3CDTF">2016-04-21T08:19:42Z</dcterms:modified>
  <cp:revision>18</cp:revision>
  <dc:subject/>
  <dc:title>Slide 1</dc:title>
</cp:coreProperties>
</file>